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725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12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022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689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572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497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409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99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295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706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50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15122-D120-4694-B703-35CB081D0FFD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932176-C2F6-4262-A687-4E5A65B64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158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A817276-44D3-4880-9AD8-8B4524BA0D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77" t="8395" r="14709" b="4917"/>
          <a:stretch/>
        </p:blipFill>
        <p:spPr>
          <a:xfrm>
            <a:off x="480051" y="1741309"/>
            <a:ext cx="4485619" cy="2378017"/>
          </a:xfrm>
          <a:prstGeom prst="rect">
            <a:avLst/>
          </a:prstGeom>
        </p:spPr>
      </p:pic>
      <p:sp>
        <p:nvSpPr>
          <p:cNvPr id="8" name="Left Bracket 7">
            <a:extLst>
              <a:ext uri="{FF2B5EF4-FFF2-40B4-BE49-F238E27FC236}">
                <a16:creationId xmlns:a16="http://schemas.microsoft.com/office/drawing/2014/main" id="{98C8C96C-280A-45F3-9B99-0ADA1DBB3423}"/>
              </a:ext>
            </a:extLst>
          </p:cNvPr>
          <p:cNvSpPr/>
          <p:nvPr/>
        </p:nvSpPr>
        <p:spPr>
          <a:xfrm rot="5400000">
            <a:off x="1976085" y="770496"/>
            <a:ext cx="92305" cy="128016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397C44E-DAEB-43CF-85AF-AB21993AF422}"/>
              </a:ext>
            </a:extLst>
          </p:cNvPr>
          <p:cNvSpPr txBox="1"/>
          <p:nvPr/>
        </p:nvSpPr>
        <p:spPr>
          <a:xfrm>
            <a:off x="1836070" y="1089970"/>
            <a:ext cx="423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7834DC0-2ACF-4896-A8B2-4E4F95A3944D}"/>
              </a:ext>
            </a:extLst>
          </p:cNvPr>
          <p:cNvSpPr txBox="1"/>
          <p:nvPr/>
        </p:nvSpPr>
        <p:spPr>
          <a:xfrm>
            <a:off x="2355608" y="786249"/>
            <a:ext cx="10613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SOX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630854-61CA-4B49-98E9-F51C896A4543}"/>
              </a:ext>
            </a:extLst>
          </p:cNvPr>
          <p:cNvSpPr txBox="1"/>
          <p:nvPr/>
        </p:nvSpPr>
        <p:spPr>
          <a:xfrm>
            <a:off x="591328" y="1454184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Strom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28EBFC-EAED-4412-B101-B9AB2FC76CA3}"/>
              </a:ext>
            </a:extLst>
          </p:cNvPr>
          <p:cNvSpPr txBox="1"/>
          <p:nvPr/>
        </p:nvSpPr>
        <p:spPr>
          <a:xfrm>
            <a:off x="2043031" y="1454183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Tumo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A7B3ABC-AAF4-464C-A94F-058A47438DB1}"/>
              </a:ext>
            </a:extLst>
          </p:cNvPr>
          <p:cNvSpPr txBox="1"/>
          <p:nvPr/>
        </p:nvSpPr>
        <p:spPr>
          <a:xfrm>
            <a:off x="3494026" y="1454183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Bulk Tissu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7674B4-0D7A-43ED-A471-A6E5212F3E22}"/>
              </a:ext>
            </a:extLst>
          </p:cNvPr>
          <p:cNvSpPr txBox="1"/>
          <p:nvPr/>
        </p:nvSpPr>
        <p:spPr>
          <a:xfrm rot="16200000">
            <a:off x="-656163" y="2538969"/>
            <a:ext cx="19338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lative Abundance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0F25C48-37CB-418B-9B64-4BA8586EE4C1}"/>
              </a:ext>
            </a:extLst>
          </p:cNvPr>
          <p:cNvGrpSpPr/>
          <p:nvPr/>
        </p:nvGrpSpPr>
        <p:grpSpPr>
          <a:xfrm>
            <a:off x="4965670" y="2018195"/>
            <a:ext cx="1708481" cy="1158862"/>
            <a:chOff x="9888437" y="1612086"/>
            <a:chExt cx="1801334" cy="1158862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C04707C0-8FCB-4C05-8AF1-CB4F4A88D7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9822" t="19643" r="7166" b="64035"/>
            <a:stretch/>
          </p:blipFill>
          <p:spPr>
            <a:xfrm>
              <a:off x="10006431" y="1882694"/>
              <a:ext cx="281922" cy="888254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A089CDF-2771-4A53-964B-FB622110410A}"/>
                </a:ext>
              </a:extLst>
            </p:cNvPr>
            <p:cNvSpPr txBox="1"/>
            <p:nvPr/>
          </p:nvSpPr>
          <p:spPr>
            <a:xfrm>
              <a:off x="9888437" y="1612086"/>
              <a:ext cx="14242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ollection Typ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5FFA407-B78C-4083-BA65-867971EFB845}"/>
                </a:ext>
              </a:extLst>
            </p:cNvPr>
            <p:cNvSpPr txBox="1"/>
            <p:nvPr/>
          </p:nvSpPr>
          <p:spPr>
            <a:xfrm>
              <a:off x="10201006" y="1889918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Strom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E1B16EF-56E1-4D46-B30E-C62EA8A329BC}"/>
                </a:ext>
              </a:extLst>
            </p:cNvPr>
            <p:cNvSpPr txBox="1"/>
            <p:nvPr/>
          </p:nvSpPr>
          <p:spPr>
            <a:xfrm>
              <a:off x="10201005" y="2141487"/>
              <a:ext cx="1488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Tumor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CDEE7F1-C4FC-4229-8F0F-A46EEBD77186}"/>
                </a:ext>
              </a:extLst>
            </p:cNvPr>
            <p:cNvSpPr txBox="1"/>
            <p:nvPr/>
          </p:nvSpPr>
          <p:spPr>
            <a:xfrm>
              <a:off x="10201006" y="2397964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ulk Tissue</a:t>
              </a:r>
            </a:p>
          </p:txBody>
        </p:sp>
      </p:grpSp>
      <p:pic>
        <p:nvPicPr>
          <p:cNvPr id="27" name="Picture 26">
            <a:extLst>
              <a:ext uri="{FF2B5EF4-FFF2-40B4-BE49-F238E27FC236}">
                <a16:creationId xmlns:a16="http://schemas.microsoft.com/office/drawing/2014/main" id="{1BAB0F0C-FBCC-49B9-BFAA-50E4B0DEAF5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77" t="6589" r="15107" b="4918"/>
          <a:stretch/>
        </p:blipFill>
        <p:spPr>
          <a:xfrm>
            <a:off x="480051" y="5304983"/>
            <a:ext cx="4485619" cy="221543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9EE5C26-0A74-4B07-ABBE-364D8CBA04DF}"/>
              </a:ext>
            </a:extLst>
          </p:cNvPr>
          <p:cNvSpPr txBox="1"/>
          <p:nvPr/>
        </p:nvSpPr>
        <p:spPr>
          <a:xfrm>
            <a:off x="1862815" y="4337714"/>
            <a:ext cx="20469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KRT23</a:t>
            </a:r>
          </a:p>
        </p:txBody>
      </p:sp>
      <p:sp>
        <p:nvSpPr>
          <p:cNvPr id="29" name="Left Bracket 28">
            <a:extLst>
              <a:ext uri="{FF2B5EF4-FFF2-40B4-BE49-F238E27FC236}">
                <a16:creationId xmlns:a16="http://schemas.microsoft.com/office/drawing/2014/main" id="{8B302DB9-618F-47F2-ACA8-D3017163EAC1}"/>
              </a:ext>
            </a:extLst>
          </p:cNvPr>
          <p:cNvSpPr/>
          <p:nvPr/>
        </p:nvSpPr>
        <p:spPr>
          <a:xfrm rot="5400000">
            <a:off x="1973327" y="4325705"/>
            <a:ext cx="92305" cy="128016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D48D3D6-675A-47D1-ABCB-0C3D82870FB6}"/>
              </a:ext>
            </a:extLst>
          </p:cNvPr>
          <p:cNvSpPr txBox="1"/>
          <p:nvPr/>
        </p:nvSpPr>
        <p:spPr>
          <a:xfrm>
            <a:off x="1900424" y="4645179"/>
            <a:ext cx="238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B75268A-0EAA-4144-896B-1334203F5C7D}"/>
              </a:ext>
            </a:extLst>
          </p:cNvPr>
          <p:cNvSpPr txBox="1"/>
          <p:nvPr/>
        </p:nvSpPr>
        <p:spPr>
          <a:xfrm>
            <a:off x="591328" y="5022544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Strom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8EC43E6-2767-4D5C-9D9A-68D0573BD318}"/>
              </a:ext>
            </a:extLst>
          </p:cNvPr>
          <p:cNvSpPr txBox="1"/>
          <p:nvPr/>
        </p:nvSpPr>
        <p:spPr>
          <a:xfrm>
            <a:off x="2043031" y="5022543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Tumo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D6EC375-F5F8-4EFC-9516-0C9D0D105B3B}"/>
              </a:ext>
            </a:extLst>
          </p:cNvPr>
          <p:cNvSpPr txBox="1"/>
          <p:nvPr/>
        </p:nvSpPr>
        <p:spPr>
          <a:xfrm>
            <a:off x="3494026" y="5022543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Bulk Tissu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637B7D5-185C-4625-B546-AE623DC49587}"/>
              </a:ext>
            </a:extLst>
          </p:cNvPr>
          <p:cNvSpPr txBox="1"/>
          <p:nvPr/>
        </p:nvSpPr>
        <p:spPr>
          <a:xfrm rot="16200000">
            <a:off x="-670440" y="6243425"/>
            <a:ext cx="19338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lative Abundance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375E8848-3EB9-48E0-B91A-5C0A574B1FC1}"/>
              </a:ext>
            </a:extLst>
          </p:cNvPr>
          <p:cNvGrpSpPr/>
          <p:nvPr/>
        </p:nvGrpSpPr>
        <p:grpSpPr>
          <a:xfrm>
            <a:off x="4965670" y="5566010"/>
            <a:ext cx="1708481" cy="1158862"/>
            <a:chOff x="9888437" y="1612086"/>
            <a:chExt cx="1801334" cy="1158862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06969772-93F5-4D2C-B50E-788DC87205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9822" t="19643" r="7166" b="64035"/>
            <a:stretch/>
          </p:blipFill>
          <p:spPr>
            <a:xfrm>
              <a:off x="10006431" y="1882694"/>
              <a:ext cx="281922" cy="888254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BD81523-20B6-49B8-9D5A-963D85735686}"/>
                </a:ext>
              </a:extLst>
            </p:cNvPr>
            <p:cNvSpPr txBox="1"/>
            <p:nvPr/>
          </p:nvSpPr>
          <p:spPr>
            <a:xfrm>
              <a:off x="9888437" y="1612086"/>
              <a:ext cx="14242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ollection Type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A1289B4-4D12-4BED-B212-5721014D82EA}"/>
                </a:ext>
              </a:extLst>
            </p:cNvPr>
            <p:cNvSpPr txBox="1"/>
            <p:nvPr/>
          </p:nvSpPr>
          <p:spPr>
            <a:xfrm>
              <a:off x="10201006" y="1889918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Strom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48FAB76-E9EB-4F92-A545-8B9178222F32}"/>
                </a:ext>
              </a:extLst>
            </p:cNvPr>
            <p:cNvSpPr txBox="1"/>
            <p:nvPr/>
          </p:nvSpPr>
          <p:spPr>
            <a:xfrm>
              <a:off x="10201005" y="2141487"/>
              <a:ext cx="1488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Tumor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AE89BC5-A38E-45C8-98EB-192994E98D8E}"/>
                </a:ext>
              </a:extLst>
            </p:cNvPr>
            <p:cNvSpPr txBox="1"/>
            <p:nvPr/>
          </p:nvSpPr>
          <p:spPr>
            <a:xfrm>
              <a:off x="10201006" y="2397964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ulk Tissu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74948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Hunt</dc:creator>
  <cp:lastModifiedBy>Allison Hunt</cp:lastModifiedBy>
  <cp:revision>1</cp:revision>
  <dcterms:created xsi:type="dcterms:W3CDTF">2024-01-04T20:30:22Z</dcterms:created>
  <dcterms:modified xsi:type="dcterms:W3CDTF">2024-01-04T20:30:36Z</dcterms:modified>
</cp:coreProperties>
</file>